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9" r:id="rId3"/>
    <p:sldId id="26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3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86D703-82B6-4ACF-925B-F6DBE0B72320}" v="24" dt="2024-07-21T13:57:33.1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39" autoAdjust="0"/>
    <p:restoredTop sz="94681"/>
  </p:normalViewPr>
  <p:slideViewPr>
    <p:cSldViewPr snapToGrid="0" showGuides="1">
      <p:cViewPr varScale="1">
        <p:scale>
          <a:sx n="59" d="100"/>
          <a:sy n="59" d="100"/>
        </p:scale>
        <p:origin x="90" y="648"/>
      </p:cViewPr>
      <p:guideLst>
        <p:guide orient="horz" pos="2160"/>
        <p:guide pos="33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cQueen, Liam W." userId="7b7474ed-bbff-42fe-95d8-55fb228d02b7" providerId="ADAL" clId="{7D40D1AA-002E-4101-A3E9-24E0B81122B7}"/>
    <pc:docChg chg="addSld modSld">
      <pc:chgData name="McQueen, Liam W." userId="7b7474ed-bbff-42fe-95d8-55fb228d02b7" providerId="ADAL" clId="{7D40D1AA-002E-4101-A3E9-24E0B81122B7}" dt="2024-07-02T12:18:11.481" v="1"/>
      <pc:docMkLst>
        <pc:docMk/>
      </pc:docMkLst>
      <pc:sldChg chg="add">
        <pc:chgData name="McQueen, Liam W." userId="7b7474ed-bbff-42fe-95d8-55fb228d02b7" providerId="ADAL" clId="{7D40D1AA-002E-4101-A3E9-24E0B81122B7}" dt="2024-07-02T12:18:11.481" v="1"/>
        <pc:sldMkLst>
          <pc:docMk/>
          <pc:sldMk cId="1224179820" sldId="268"/>
        </pc:sldMkLst>
      </pc:sldChg>
      <pc:sldChg chg="add">
        <pc:chgData name="McQueen, Liam W." userId="7b7474ed-bbff-42fe-95d8-55fb228d02b7" providerId="ADAL" clId="{7D40D1AA-002E-4101-A3E9-24E0B81122B7}" dt="2024-07-02T12:18:04.708" v="0"/>
        <pc:sldMkLst>
          <pc:docMk/>
          <pc:sldMk cId="2205913967" sldId="269"/>
        </pc:sldMkLst>
      </pc:sldChg>
    </pc:docChg>
  </pc:docChgLst>
  <pc:docChgLst>
    <pc:chgData name="McQueen, Liam W." userId="7b7474ed-bbff-42fe-95d8-55fb228d02b7" providerId="ADAL" clId="{0086D703-82B6-4ACF-925B-F6DBE0B72320}"/>
    <pc:docChg chg="undo custSel modSld">
      <pc:chgData name="McQueen, Liam W." userId="7b7474ed-bbff-42fe-95d8-55fb228d02b7" providerId="ADAL" clId="{0086D703-82B6-4ACF-925B-F6DBE0B72320}" dt="2024-08-02T20:29:57.638" v="1385" actId="6549"/>
      <pc:docMkLst>
        <pc:docMk/>
      </pc:docMkLst>
      <pc:sldChg chg="addSp modSp mod">
        <pc:chgData name="McQueen, Liam W." userId="7b7474ed-bbff-42fe-95d8-55fb228d02b7" providerId="ADAL" clId="{0086D703-82B6-4ACF-925B-F6DBE0B72320}" dt="2024-08-02T20:29:57.638" v="1385" actId="6549"/>
        <pc:sldMkLst>
          <pc:docMk/>
          <pc:sldMk cId="3472921919" sldId="261"/>
        </pc:sldMkLst>
        <pc:spChg chg="add mod">
          <ac:chgData name="McQueen, Liam W." userId="7b7474ed-bbff-42fe-95d8-55fb228d02b7" providerId="ADAL" clId="{0086D703-82B6-4ACF-925B-F6DBE0B72320}" dt="2024-07-09T15:45:53.120" v="14" actId="1076"/>
          <ac:spMkLst>
            <pc:docMk/>
            <pc:sldMk cId="3472921919" sldId="261"/>
            <ac:spMk id="2" creationId="{529AC27E-608C-181C-A4D6-15A758A9A5EA}"/>
          </ac:spMkLst>
        </pc:spChg>
        <pc:spChg chg="add mod">
          <ac:chgData name="McQueen, Liam W." userId="7b7474ed-bbff-42fe-95d8-55fb228d02b7" providerId="ADAL" clId="{0086D703-82B6-4ACF-925B-F6DBE0B72320}" dt="2024-07-09T15:46:16.410" v="20" actId="1076"/>
          <ac:spMkLst>
            <pc:docMk/>
            <pc:sldMk cId="3472921919" sldId="261"/>
            <ac:spMk id="3" creationId="{890FD77D-E0B5-5E3A-5EF9-CEA1B97DDFB0}"/>
          </ac:spMkLst>
        </pc:spChg>
        <pc:spChg chg="add mod">
          <ac:chgData name="McQueen, Liam W." userId="7b7474ed-bbff-42fe-95d8-55fb228d02b7" providerId="ADAL" clId="{0086D703-82B6-4ACF-925B-F6DBE0B72320}" dt="2024-08-02T20:29:57.638" v="1385" actId="6549"/>
          <ac:spMkLst>
            <pc:docMk/>
            <pc:sldMk cId="3472921919" sldId="261"/>
            <ac:spMk id="6" creationId="{4AFEE865-71F0-2634-FC21-C8D4CAABFF80}"/>
          </ac:spMkLst>
        </pc:spChg>
        <pc:spChg chg="add mod">
          <ac:chgData name="McQueen, Liam W." userId="7b7474ed-bbff-42fe-95d8-55fb228d02b7" providerId="ADAL" clId="{0086D703-82B6-4ACF-925B-F6DBE0B72320}" dt="2024-07-18T15:48:12.047" v="385" actId="1076"/>
          <ac:spMkLst>
            <pc:docMk/>
            <pc:sldMk cId="3472921919" sldId="261"/>
            <ac:spMk id="8" creationId="{D7722DF2-2F53-C931-7174-5BED055042C6}"/>
          </ac:spMkLst>
        </pc:spChg>
        <pc:spChg chg="add mod">
          <ac:chgData name="McQueen, Liam W." userId="7b7474ed-bbff-42fe-95d8-55fb228d02b7" providerId="ADAL" clId="{0086D703-82B6-4ACF-925B-F6DBE0B72320}" dt="2024-07-18T15:48:20.326" v="387" actId="1076"/>
          <ac:spMkLst>
            <pc:docMk/>
            <pc:sldMk cId="3472921919" sldId="261"/>
            <ac:spMk id="9" creationId="{991019EA-CF31-8336-1A51-23294AA93F97}"/>
          </ac:spMkLst>
        </pc:spChg>
        <pc:spChg chg="add mod">
          <ac:chgData name="McQueen, Liam W." userId="7b7474ed-bbff-42fe-95d8-55fb228d02b7" providerId="ADAL" clId="{0086D703-82B6-4ACF-925B-F6DBE0B72320}" dt="2024-07-18T15:48:45.164" v="398" actId="1035"/>
          <ac:spMkLst>
            <pc:docMk/>
            <pc:sldMk cId="3472921919" sldId="261"/>
            <ac:spMk id="10" creationId="{3380B7B8-9414-A6E3-6589-5A9B72FF9A95}"/>
          </ac:spMkLst>
        </pc:spChg>
        <pc:spChg chg="add mod">
          <ac:chgData name="McQueen, Liam W." userId="7b7474ed-bbff-42fe-95d8-55fb228d02b7" providerId="ADAL" clId="{0086D703-82B6-4ACF-925B-F6DBE0B72320}" dt="2024-07-18T15:48:51.915" v="400" actId="1076"/>
          <ac:spMkLst>
            <pc:docMk/>
            <pc:sldMk cId="3472921919" sldId="261"/>
            <ac:spMk id="11" creationId="{7A03A430-F88D-64B9-47FA-A9625DA3EA32}"/>
          </ac:spMkLst>
        </pc:spChg>
        <pc:spChg chg="add mod">
          <ac:chgData name="McQueen, Liam W." userId="7b7474ed-bbff-42fe-95d8-55fb228d02b7" providerId="ADAL" clId="{0086D703-82B6-4ACF-925B-F6DBE0B72320}" dt="2024-07-18T15:50:30.421" v="483" actId="1076"/>
          <ac:spMkLst>
            <pc:docMk/>
            <pc:sldMk cId="3472921919" sldId="261"/>
            <ac:spMk id="12" creationId="{6A8A1ED6-355E-9794-5E25-1C005C5F8E7E}"/>
          </ac:spMkLst>
        </pc:spChg>
        <pc:spChg chg="add mod">
          <ac:chgData name="McQueen, Liam W." userId="7b7474ed-bbff-42fe-95d8-55fb228d02b7" providerId="ADAL" clId="{0086D703-82B6-4ACF-925B-F6DBE0B72320}" dt="2024-07-18T15:50:25.553" v="482" actId="1076"/>
          <ac:spMkLst>
            <pc:docMk/>
            <pc:sldMk cId="3472921919" sldId="261"/>
            <ac:spMk id="13" creationId="{48205CA9-E07A-D8CD-7179-F2FD1197F3B2}"/>
          </ac:spMkLst>
        </pc:spChg>
        <pc:picChg chg="mod ord modCrop">
          <ac:chgData name="McQueen, Liam W." userId="7b7474ed-bbff-42fe-95d8-55fb228d02b7" providerId="ADAL" clId="{0086D703-82B6-4ACF-925B-F6DBE0B72320}" dt="2024-07-18T15:47:28.758" v="369" actId="732"/>
          <ac:picMkLst>
            <pc:docMk/>
            <pc:sldMk cId="3472921919" sldId="261"/>
            <ac:picMk id="5" creationId="{55A37493-A438-B073-C972-BFB6C2ADAA19}"/>
          </ac:picMkLst>
        </pc:picChg>
        <pc:picChg chg="mod modCrop">
          <ac:chgData name="McQueen, Liam W." userId="7b7474ed-bbff-42fe-95d8-55fb228d02b7" providerId="ADAL" clId="{0086D703-82B6-4ACF-925B-F6DBE0B72320}" dt="2024-07-18T15:47:36.630" v="370" actId="732"/>
          <ac:picMkLst>
            <pc:docMk/>
            <pc:sldMk cId="3472921919" sldId="261"/>
            <ac:picMk id="7" creationId="{12B5B2BE-B23F-9DF8-9672-3A6E4FA2F92D}"/>
          </ac:picMkLst>
        </pc:picChg>
        <pc:picChg chg="mod modCrop">
          <ac:chgData name="McQueen, Liam W." userId="7b7474ed-bbff-42fe-95d8-55fb228d02b7" providerId="ADAL" clId="{0086D703-82B6-4ACF-925B-F6DBE0B72320}" dt="2024-07-18T15:50:21.762" v="481" actId="1076"/>
          <ac:picMkLst>
            <pc:docMk/>
            <pc:sldMk cId="3472921919" sldId="261"/>
            <ac:picMk id="15" creationId="{DBE90E7F-487A-0230-0778-109AFD2AA581}"/>
          </ac:picMkLst>
        </pc:picChg>
      </pc:sldChg>
      <pc:sldChg chg="addSp delSp modSp mod">
        <pc:chgData name="McQueen, Liam W." userId="7b7474ed-bbff-42fe-95d8-55fb228d02b7" providerId="ADAL" clId="{0086D703-82B6-4ACF-925B-F6DBE0B72320}" dt="2024-07-21T13:59:49.911" v="1383" actId="1036"/>
        <pc:sldMkLst>
          <pc:docMk/>
          <pc:sldMk cId="1224179820" sldId="268"/>
        </pc:sldMkLst>
        <pc:spChg chg="mod">
          <ac:chgData name="McQueen, Liam W." userId="7b7474ed-bbff-42fe-95d8-55fb228d02b7" providerId="ADAL" clId="{0086D703-82B6-4ACF-925B-F6DBE0B72320}" dt="2024-07-18T15:42:59.755" v="203" actId="1076"/>
          <ac:spMkLst>
            <pc:docMk/>
            <pc:sldMk cId="1224179820" sldId="268"/>
            <ac:spMk id="2" creationId="{0ACD483C-898F-4C54-A233-99FA12C82672}"/>
          </ac:spMkLst>
        </pc:spChg>
        <pc:spChg chg="mod">
          <ac:chgData name="McQueen, Liam W." userId="7b7474ed-bbff-42fe-95d8-55fb228d02b7" providerId="ADAL" clId="{0086D703-82B6-4ACF-925B-F6DBE0B72320}" dt="2024-07-18T15:43:05.849" v="204" actId="1076"/>
          <ac:spMkLst>
            <pc:docMk/>
            <pc:sldMk cId="1224179820" sldId="268"/>
            <ac:spMk id="3" creationId="{38B4C3AA-D62E-4593-A48A-B3B33B5E64D6}"/>
          </ac:spMkLst>
        </pc:spChg>
        <pc:spChg chg="add mod">
          <ac:chgData name="McQueen, Liam W." userId="7b7474ed-bbff-42fe-95d8-55fb228d02b7" providerId="ADAL" clId="{0086D703-82B6-4ACF-925B-F6DBE0B72320}" dt="2024-07-21T13:59:48.564" v="1382" actId="1076"/>
          <ac:spMkLst>
            <pc:docMk/>
            <pc:sldMk cId="1224179820" sldId="268"/>
            <ac:spMk id="5" creationId="{5BAF24D1-2BC1-5C34-4DC8-30653011B18D}"/>
          </ac:spMkLst>
        </pc:spChg>
        <pc:spChg chg="mod">
          <ac:chgData name="McQueen, Liam W." userId="7b7474ed-bbff-42fe-95d8-55fb228d02b7" providerId="ADAL" clId="{0086D703-82B6-4ACF-925B-F6DBE0B72320}" dt="2024-07-18T15:42:59.755" v="203" actId="1076"/>
          <ac:spMkLst>
            <pc:docMk/>
            <pc:sldMk cId="1224179820" sldId="268"/>
            <ac:spMk id="7" creationId="{E307BC41-11FB-4178-8777-33E1BEE16CA0}"/>
          </ac:spMkLst>
        </pc:spChg>
        <pc:spChg chg="mod">
          <ac:chgData name="McQueen, Liam W." userId="7b7474ed-bbff-42fe-95d8-55fb228d02b7" providerId="ADAL" clId="{0086D703-82B6-4ACF-925B-F6DBE0B72320}" dt="2024-07-18T15:42:59.755" v="203" actId="1076"/>
          <ac:spMkLst>
            <pc:docMk/>
            <pc:sldMk cId="1224179820" sldId="268"/>
            <ac:spMk id="8" creationId="{612A62B2-AE1A-4EDF-8F43-36A00E2ECD63}"/>
          </ac:spMkLst>
        </pc:spChg>
        <pc:spChg chg="add del mod">
          <ac:chgData name="McQueen, Liam W." userId="7b7474ed-bbff-42fe-95d8-55fb228d02b7" providerId="ADAL" clId="{0086D703-82B6-4ACF-925B-F6DBE0B72320}" dt="2024-07-18T15:57:56.538" v="975" actId="478"/>
          <ac:spMkLst>
            <pc:docMk/>
            <pc:sldMk cId="1224179820" sldId="268"/>
            <ac:spMk id="13" creationId="{3D3ED514-6BB3-D1F6-9DA7-0AC23C82D62D}"/>
          </ac:spMkLst>
        </pc:spChg>
        <pc:spChg chg="add del mod">
          <ac:chgData name="McQueen, Liam W." userId="7b7474ed-bbff-42fe-95d8-55fb228d02b7" providerId="ADAL" clId="{0086D703-82B6-4ACF-925B-F6DBE0B72320}" dt="2024-07-18T15:57:53.880" v="974" actId="478"/>
          <ac:spMkLst>
            <pc:docMk/>
            <pc:sldMk cId="1224179820" sldId="268"/>
            <ac:spMk id="14" creationId="{30525C02-D2EB-12DB-67FD-6D97562E7CD6}"/>
          </ac:spMkLst>
        </pc:spChg>
        <pc:spChg chg="mod">
          <ac:chgData name="McQueen, Liam W." userId="7b7474ed-bbff-42fe-95d8-55fb228d02b7" providerId="ADAL" clId="{0086D703-82B6-4ACF-925B-F6DBE0B72320}" dt="2024-07-18T15:42:59.755" v="203" actId="1076"/>
          <ac:spMkLst>
            <pc:docMk/>
            <pc:sldMk cId="1224179820" sldId="268"/>
            <ac:spMk id="19" creationId="{FE57356D-FBDD-4844-B5D5-F31E10E4B1F5}"/>
          </ac:spMkLst>
        </pc:spChg>
        <pc:spChg chg="add mod">
          <ac:chgData name="McQueen, Liam W." userId="7b7474ed-bbff-42fe-95d8-55fb228d02b7" providerId="ADAL" clId="{0086D703-82B6-4ACF-925B-F6DBE0B72320}" dt="2024-07-19T19:58:37.676" v="1278" actId="1076"/>
          <ac:spMkLst>
            <pc:docMk/>
            <pc:sldMk cId="1224179820" sldId="268"/>
            <ac:spMk id="21" creationId="{36B007B2-388B-9899-50DE-5E8470944186}"/>
          </ac:spMkLst>
        </pc:spChg>
        <pc:spChg chg="add mod">
          <ac:chgData name="McQueen, Liam W." userId="7b7474ed-bbff-42fe-95d8-55fb228d02b7" providerId="ADAL" clId="{0086D703-82B6-4ACF-925B-F6DBE0B72320}" dt="2024-07-19T19:58:45.371" v="1279" actId="1076"/>
          <ac:spMkLst>
            <pc:docMk/>
            <pc:sldMk cId="1224179820" sldId="268"/>
            <ac:spMk id="27" creationId="{43BE7F93-009C-0571-4B63-FF9AC9950288}"/>
          </ac:spMkLst>
        </pc:spChg>
        <pc:spChg chg="add mod">
          <ac:chgData name="McQueen, Liam W." userId="7b7474ed-bbff-42fe-95d8-55fb228d02b7" providerId="ADAL" clId="{0086D703-82B6-4ACF-925B-F6DBE0B72320}" dt="2024-07-19T19:58:31.163" v="1277" actId="1076"/>
          <ac:spMkLst>
            <pc:docMk/>
            <pc:sldMk cId="1224179820" sldId="268"/>
            <ac:spMk id="30" creationId="{17A570F2-FDAB-434D-837E-70AF45DF0D8E}"/>
          </ac:spMkLst>
        </pc:spChg>
        <pc:spChg chg="add mod">
          <ac:chgData name="McQueen, Liam W." userId="7b7474ed-bbff-42fe-95d8-55fb228d02b7" providerId="ADAL" clId="{0086D703-82B6-4ACF-925B-F6DBE0B72320}" dt="2024-07-19T19:58:54.972" v="1282" actId="1076"/>
          <ac:spMkLst>
            <pc:docMk/>
            <pc:sldMk cId="1224179820" sldId="268"/>
            <ac:spMk id="32" creationId="{5A343D44-E104-018A-81C5-EFB04BD52485}"/>
          </ac:spMkLst>
        </pc:spChg>
        <pc:spChg chg="add mod">
          <ac:chgData name="McQueen, Liam W." userId="7b7474ed-bbff-42fe-95d8-55fb228d02b7" providerId="ADAL" clId="{0086D703-82B6-4ACF-925B-F6DBE0B72320}" dt="2024-07-19T19:59:02.051" v="1284" actId="1076"/>
          <ac:spMkLst>
            <pc:docMk/>
            <pc:sldMk cId="1224179820" sldId="268"/>
            <ac:spMk id="34" creationId="{46FD1AEC-C25D-ABC5-E6D8-AF8E9BC8B906}"/>
          </ac:spMkLst>
        </pc:spChg>
        <pc:spChg chg="add mod">
          <ac:chgData name="McQueen, Liam W." userId="7b7474ed-bbff-42fe-95d8-55fb228d02b7" providerId="ADAL" clId="{0086D703-82B6-4ACF-925B-F6DBE0B72320}" dt="2024-07-19T19:59:33.204" v="1311" actId="1076"/>
          <ac:spMkLst>
            <pc:docMk/>
            <pc:sldMk cId="1224179820" sldId="268"/>
            <ac:spMk id="36" creationId="{85DC10E5-F5C0-EF32-6775-9E4B28D3DF40}"/>
          </ac:spMkLst>
        </pc:spChg>
        <pc:picChg chg="mod">
          <ac:chgData name="McQueen, Liam W." userId="7b7474ed-bbff-42fe-95d8-55fb228d02b7" providerId="ADAL" clId="{0086D703-82B6-4ACF-925B-F6DBE0B72320}" dt="2024-07-21T13:57:43.936" v="1368" actId="1076"/>
          <ac:picMkLst>
            <pc:docMk/>
            <pc:sldMk cId="1224179820" sldId="268"/>
            <ac:picMk id="6" creationId="{4EB493E3-4890-4456-8936-4C6418BE128E}"/>
          </ac:picMkLst>
        </pc:picChg>
        <pc:picChg chg="mod">
          <ac:chgData name="McQueen, Liam W." userId="7b7474ed-bbff-42fe-95d8-55fb228d02b7" providerId="ADAL" clId="{0086D703-82B6-4ACF-925B-F6DBE0B72320}" dt="2024-07-21T13:59:48.212" v="1381" actId="1076"/>
          <ac:picMkLst>
            <pc:docMk/>
            <pc:sldMk cId="1224179820" sldId="268"/>
            <ac:picMk id="9" creationId="{CE0ABE02-6170-96E3-D471-DEE0C2640CD9}"/>
          </ac:picMkLst>
        </pc:picChg>
        <pc:picChg chg="mod">
          <ac:chgData name="McQueen, Liam W." userId="7b7474ed-bbff-42fe-95d8-55fb228d02b7" providerId="ADAL" clId="{0086D703-82B6-4ACF-925B-F6DBE0B72320}" dt="2024-07-21T13:59:47.890" v="1380" actId="1076"/>
          <ac:picMkLst>
            <pc:docMk/>
            <pc:sldMk cId="1224179820" sldId="268"/>
            <ac:picMk id="11" creationId="{DFBF2838-B6EA-CF7D-18A5-9BB721EC6FD0}"/>
          </ac:picMkLst>
        </pc:picChg>
        <pc:picChg chg="mod">
          <ac:chgData name="McQueen, Liam W." userId="7b7474ed-bbff-42fe-95d8-55fb228d02b7" providerId="ADAL" clId="{0086D703-82B6-4ACF-925B-F6DBE0B72320}" dt="2024-07-21T13:59:47.890" v="1380" actId="1076"/>
          <ac:picMkLst>
            <pc:docMk/>
            <pc:sldMk cId="1224179820" sldId="268"/>
            <ac:picMk id="12" creationId="{D9691D14-600C-DC9F-58C7-8B26230ACFE0}"/>
          </ac:picMkLst>
        </pc:picChg>
        <pc:picChg chg="mod">
          <ac:chgData name="McQueen, Liam W." userId="7b7474ed-bbff-42fe-95d8-55fb228d02b7" providerId="ADAL" clId="{0086D703-82B6-4ACF-925B-F6DBE0B72320}" dt="2024-07-21T13:59:49.911" v="1383" actId="1036"/>
          <ac:picMkLst>
            <pc:docMk/>
            <pc:sldMk cId="1224179820" sldId="268"/>
            <ac:picMk id="22" creationId="{D3E307AE-D5C6-4FDF-8BCE-39889E133374}"/>
          </ac:picMkLst>
        </pc:picChg>
        <pc:picChg chg="mod">
          <ac:chgData name="McQueen, Liam W." userId="7b7474ed-bbff-42fe-95d8-55fb228d02b7" providerId="ADAL" clId="{0086D703-82B6-4ACF-925B-F6DBE0B72320}" dt="2024-07-21T13:57:10.121" v="1352" actId="14100"/>
          <ac:picMkLst>
            <pc:docMk/>
            <pc:sldMk cId="1224179820" sldId="268"/>
            <ac:picMk id="23" creationId="{57DC277F-6CBD-4BDC-A3ED-B894850EA929}"/>
          </ac:picMkLst>
        </pc:picChg>
        <pc:picChg chg="mod">
          <ac:chgData name="McQueen, Liam W." userId="7b7474ed-bbff-42fe-95d8-55fb228d02b7" providerId="ADAL" clId="{0086D703-82B6-4ACF-925B-F6DBE0B72320}" dt="2024-07-21T13:57:47.495" v="1369" actId="1076"/>
          <ac:picMkLst>
            <pc:docMk/>
            <pc:sldMk cId="1224179820" sldId="268"/>
            <ac:picMk id="24" creationId="{6B881CFB-4B56-4934-9479-A9E0B8076D5E}"/>
          </ac:picMkLst>
        </pc:picChg>
        <pc:picChg chg="mod">
          <ac:chgData name="McQueen, Liam W." userId="7b7474ed-bbff-42fe-95d8-55fb228d02b7" providerId="ADAL" clId="{0086D703-82B6-4ACF-925B-F6DBE0B72320}" dt="2024-07-21T13:57:58.251" v="1370" actId="1076"/>
          <ac:picMkLst>
            <pc:docMk/>
            <pc:sldMk cId="1224179820" sldId="268"/>
            <ac:picMk id="26" creationId="{E51F99F0-5BE8-4C06-8A41-C26731F8A028}"/>
          </ac:picMkLst>
        </pc:picChg>
        <pc:picChg chg="mod">
          <ac:chgData name="McQueen, Liam W." userId="7b7474ed-bbff-42fe-95d8-55fb228d02b7" providerId="ADAL" clId="{0086D703-82B6-4ACF-925B-F6DBE0B72320}" dt="2024-07-21T13:57:40.630" v="1367" actId="1076"/>
          <ac:picMkLst>
            <pc:docMk/>
            <pc:sldMk cId="1224179820" sldId="268"/>
            <ac:picMk id="28" creationId="{62D0BCC2-7A62-4B4A-931D-5EE8839743EA}"/>
          </ac:picMkLst>
        </pc:picChg>
        <pc:cxnChg chg="del">
          <ac:chgData name="McQueen, Liam W." userId="7b7474ed-bbff-42fe-95d8-55fb228d02b7" providerId="ADAL" clId="{0086D703-82B6-4ACF-925B-F6DBE0B72320}" dt="2024-07-19T19:52:58.442" v="1250" actId="478"/>
          <ac:cxnSpMkLst>
            <pc:docMk/>
            <pc:sldMk cId="1224179820" sldId="268"/>
            <ac:cxnSpMk id="10" creationId="{92165EF5-E2F0-E0EF-CF5D-7BF99FB43AAB}"/>
          </ac:cxnSpMkLst>
        </pc:cxnChg>
        <pc:cxnChg chg="add mod">
          <ac:chgData name="McQueen, Liam W." userId="7b7474ed-bbff-42fe-95d8-55fb228d02b7" providerId="ADAL" clId="{0086D703-82B6-4ACF-925B-F6DBE0B72320}" dt="2024-07-19T20:00:12.338" v="1316" actId="1582"/>
          <ac:cxnSpMkLst>
            <pc:docMk/>
            <pc:sldMk cId="1224179820" sldId="268"/>
            <ac:cxnSpMk id="16" creationId="{BAAA09C8-C770-985F-8F25-1972D305DBC7}"/>
          </ac:cxnSpMkLst>
        </pc:cxnChg>
        <pc:cxnChg chg="add mod">
          <ac:chgData name="McQueen, Liam W." userId="7b7474ed-bbff-42fe-95d8-55fb228d02b7" providerId="ADAL" clId="{0086D703-82B6-4ACF-925B-F6DBE0B72320}" dt="2024-07-19T20:00:12.338" v="1316" actId="1582"/>
          <ac:cxnSpMkLst>
            <pc:docMk/>
            <pc:sldMk cId="1224179820" sldId="268"/>
            <ac:cxnSpMk id="25" creationId="{626A8B99-EE88-4D2D-E990-A4B5B4B41787}"/>
          </ac:cxnSpMkLst>
        </pc:cxnChg>
        <pc:cxnChg chg="add mod">
          <ac:chgData name="McQueen, Liam W." userId="7b7474ed-bbff-42fe-95d8-55fb228d02b7" providerId="ADAL" clId="{0086D703-82B6-4ACF-925B-F6DBE0B72320}" dt="2024-07-19T20:00:12.338" v="1316" actId="1582"/>
          <ac:cxnSpMkLst>
            <pc:docMk/>
            <pc:sldMk cId="1224179820" sldId="268"/>
            <ac:cxnSpMk id="29" creationId="{2E5F5F02-62C0-02C3-A173-3FAFA9A56293}"/>
          </ac:cxnSpMkLst>
        </pc:cxnChg>
        <pc:cxnChg chg="add mod">
          <ac:chgData name="McQueen, Liam W." userId="7b7474ed-bbff-42fe-95d8-55fb228d02b7" providerId="ADAL" clId="{0086D703-82B6-4ACF-925B-F6DBE0B72320}" dt="2024-07-19T20:00:12.338" v="1316" actId="1582"/>
          <ac:cxnSpMkLst>
            <pc:docMk/>
            <pc:sldMk cId="1224179820" sldId="268"/>
            <ac:cxnSpMk id="31" creationId="{087DE11D-8EF9-7813-9D3E-2A766782A53A}"/>
          </ac:cxnSpMkLst>
        </pc:cxnChg>
        <pc:cxnChg chg="add mod">
          <ac:chgData name="McQueen, Liam W." userId="7b7474ed-bbff-42fe-95d8-55fb228d02b7" providerId="ADAL" clId="{0086D703-82B6-4ACF-925B-F6DBE0B72320}" dt="2024-07-19T20:00:12.338" v="1316" actId="1582"/>
          <ac:cxnSpMkLst>
            <pc:docMk/>
            <pc:sldMk cId="1224179820" sldId="268"/>
            <ac:cxnSpMk id="33" creationId="{1A0252D6-66BC-CF57-EDE6-C9F236E29118}"/>
          </ac:cxnSpMkLst>
        </pc:cxnChg>
        <pc:cxnChg chg="add mod">
          <ac:chgData name="McQueen, Liam W." userId="7b7474ed-bbff-42fe-95d8-55fb228d02b7" providerId="ADAL" clId="{0086D703-82B6-4ACF-925B-F6DBE0B72320}" dt="2024-07-19T20:00:12.338" v="1316" actId="1582"/>
          <ac:cxnSpMkLst>
            <pc:docMk/>
            <pc:sldMk cId="1224179820" sldId="268"/>
            <ac:cxnSpMk id="35" creationId="{AC2764E4-5104-3236-2BFA-FCD5FA666C13}"/>
          </ac:cxnSpMkLst>
        </pc:cxnChg>
      </pc:sldChg>
      <pc:sldChg chg="addSp delSp modSp mod">
        <pc:chgData name="McQueen, Liam W." userId="7b7474ed-bbff-42fe-95d8-55fb228d02b7" providerId="ADAL" clId="{0086D703-82B6-4ACF-925B-F6DBE0B72320}" dt="2024-07-18T16:02:54.568" v="1247" actId="20577"/>
        <pc:sldMkLst>
          <pc:docMk/>
          <pc:sldMk cId="2205913967" sldId="269"/>
        </pc:sldMkLst>
        <pc:spChg chg="add mod">
          <ac:chgData name="McQueen, Liam W." userId="7b7474ed-bbff-42fe-95d8-55fb228d02b7" providerId="ADAL" clId="{0086D703-82B6-4ACF-925B-F6DBE0B72320}" dt="2024-07-18T16:02:54.568" v="1247" actId="20577"/>
          <ac:spMkLst>
            <pc:docMk/>
            <pc:sldMk cId="2205913967" sldId="269"/>
            <ac:spMk id="10" creationId="{6863C619-1BF1-0F6C-288D-672943F56D66}"/>
          </ac:spMkLst>
        </pc:spChg>
        <pc:grpChg chg="add mod">
          <ac:chgData name="McQueen, Liam W." userId="7b7474ed-bbff-42fe-95d8-55fb228d02b7" providerId="ADAL" clId="{0086D703-82B6-4ACF-925B-F6DBE0B72320}" dt="2024-07-18T15:40:53.853" v="74" actId="1076"/>
          <ac:grpSpMkLst>
            <pc:docMk/>
            <pc:sldMk cId="2205913967" sldId="269"/>
            <ac:grpSpMk id="9" creationId="{5CD085DB-0CB7-9E56-9C34-8BF2D76DAFC6}"/>
          </ac:grpSpMkLst>
        </pc:grpChg>
        <pc:picChg chg="del">
          <ac:chgData name="McQueen, Liam W." userId="7b7474ed-bbff-42fe-95d8-55fb228d02b7" providerId="ADAL" clId="{0086D703-82B6-4ACF-925B-F6DBE0B72320}" dt="2024-07-10T15:07:26" v="21" actId="478"/>
          <ac:picMkLst>
            <pc:docMk/>
            <pc:sldMk cId="2205913967" sldId="269"/>
            <ac:picMk id="2" creationId="{625E3D23-BCDD-C262-7DC8-5D4BADFA27D3}"/>
          </ac:picMkLst>
        </pc:picChg>
        <pc:picChg chg="mod">
          <ac:chgData name="McQueen, Liam W." userId="7b7474ed-bbff-42fe-95d8-55fb228d02b7" providerId="ADAL" clId="{0086D703-82B6-4ACF-925B-F6DBE0B72320}" dt="2024-07-10T15:09:01.187" v="65" actId="164"/>
          <ac:picMkLst>
            <pc:docMk/>
            <pc:sldMk cId="2205913967" sldId="269"/>
            <ac:picMk id="3" creationId="{1EF6E3AA-0821-D1C6-AF21-87CA2C7D5698}"/>
          </ac:picMkLst>
        </pc:picChg>
        <pc:picChg chg="mod">
          <ac:chgData name="McQueen, Liam W." userId="7b7474ed-bbff-42fe-95d8-55fb228d02b7" providerId="ADAL" clId="{0086D703-82B6-4ACF-925B-F6DBE0B72320}" dt="2024-07-10T15:09:01.187" v="65" actId="164"/>
          <ac:picMkLst>
            <pc:docMk/>
            <pc:sldMk cId="2205913967" sldId="269"/>
            <ac:picMk id="4" creationId="{5DF4B2BB-BCEF-6488-21FD-E3C2A08987EE}"/>
          </ac:picMkLst>
        </pc:picChg>
        <pc:picChg chg="mod">
          <ac:chgData name="McQueen, Liam W." userId="7b7474ed-bbff-42fe-95d8-55fb228d02b7" providerId="ADAL" clId="{0086D703-82B6-4ACF-925B-F6DBE0B72320}" dt="2024-07-10T15:09:01.187" v="65" actId="164"/>
          <ac:picMkLst>
            <pc:docMk/>
            <pc:sldMk cId="2205913967" sldId="269"/>
            <ac:picMk id="5" creationId="{2500EB78-3B3F-71FE-357C-19A7DFD5C846}"/>
          </ac:picMkLst>
        </pc:picChg>
        <pc:picChg chg="mod">
          <ac:chgData name="McQueen, Liam W." userId="7b7474ed-bbff-42fe-95d8-55fb228d02b7" providerId="ADAL" clId="{0086D703-82B6-4ACF-925B-F6DBE0B72320}" dt="2024-07-10T15:09:01.187" v="65" actId="164"/>
          <ac:picMkLst>
            <pc:docMk/>
            <pc:sldMk cId="2205913967" sldId="269"/>
            <ac:picMk id="6" creationId="{AED7FC9A-376C-C747-7B74-6FD8EBB733CE}"/>
          </ac:picMkLst>
        </pc:picChg>
        <pc:picChg chg="mod">
          <ac:chgData name="McQueen, Liam W." userId="7b7474ed-bbff-42fe-95d8-55fb228d02b7" providerId="ADAL" clId="{0086D703-82B6-4ACF-925B-F6DBE0B72320}" dt="2024-07-10T15:09:01.187" v="65" actId="164"/>
          <ac:picMkLst>
            <pc:docMk/>
            <pc:sldMk cId="2205913967" sldId="269"/>
            <ac:picMk id="7" creationId="{8250A862-69AD-CF51-36C9-0554698EC822}"/>
          </ac:picMkLst>
        </pc:picChg>
        <pc:picChg chg="mod">
          <ac:chgData name="McQueen, Liam W." userId="7b7474ed-bbff-42fe-95d8-55fb228d02b7" providerId="ADAL" clId="{0086D703-82B6-4ACF-925B-F6DBE0B72320}" dt="2024-07-10T15:09:01.187" v="65" actId="164"/>
          <ac:picMkLst>
            <pc:docMk/>
            <pc:sldMk cId="2205913967" sldId="269"/>
            <ac:picMk id="8" creationId="{827829A5-3EA7-BB18-0B78-0B923D4A298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3AB078-969B-7701-A062-AC6450406A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90F2DAD-3A22-6C7B-023D-AA9448F165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48070E-08C1-4AC1-357D-2957F90BE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EBEF17-3280-44C2-7623-7445F1047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5FAB13-FE23-E61E-8AE9-3CCC9BA8C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873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1494F8-24AE-1EC2-00C6-B83FAD3CED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202538-4489-EF83-0157-95A2F7E604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07E551-9E9D-4224-909A-6DD73F961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2F69E2-5848-C32B-6716-E44C1EC3A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CADF1C-931D-5474-35EB-5D25B5C73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0976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593E9C9-5710-7CED-4548-4B519A11EA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62702C-76EE-FDFB-0FDC-4898C9C546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3E1F8F-4FE6-561E-9A90-CB84D771D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11876A-E334-A423-63F9-CA233DE705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5BC181-C16D-EA4D-76EB-4F1E29A8F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0464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580A47-A3D2-A99F-6F9B-DE5D912678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9C337E-2168-7719-FD6B-DA3F05B7DB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6E60FE-48B6-8684-1BA3-999CDE839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807714-FD8B-F451-5271-FCB1AF7D6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C3C625-854D-4B89-50EE-261F329EC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6685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B454A0-1A5A-0E26-CA8B-DFDFC368C0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4997E0-1C26-F20F-F58B-E67BB1D697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089E3F-6250-2F86-E99B-40B010B91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0339FA-1B4E-C5E7-0915-FD510A2920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C6548F-5D3B-D859-2F4E-37BB74475A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7467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819CC-7081-390F-E73D-88ED37EDAF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4EE6C8-7504-1838-8A90-96D9305D84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0AEA47-B741-4837-BD5C-8CEF64824A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53D19A-05E9-0EF0-96A9-E0FB60358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18EE44-1AC4-A802-80B3-DAE72278A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6231BF-A616-B2DD-61CB-F37A485DE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1373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35EBBA-7638-FD38-D403-F677E2C23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547E63-4F82-200B-03EB-8B8E8EEE0D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C46D4E-DE54-DFD1-A15A-031705CD2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DF7298-BC9D-5788-508C-FDC67A775D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4F36C5-1983-ADB1-B58B-18591470BD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ECDD733-D8AE-C923-BF65-6EA08AC09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BA5C41-AFD6-F978-1C4F-3F98823DA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E40016E-5952-7F25-751C-204999DB0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5977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9BFDA-3F44-09E1-6127-4AEB9C8246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6B24D4-3A2C-B831-C538-308B36429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106900-B908-2182-8368-9785C9450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DB912A-F071-D40F-F1DE-D5513D328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62302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6341CD9-0C09-827A-1F7C-A52B0B2E8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4081A6-AA59-96E9-4200-EEC8A839EC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A77EC5-AC9C-7215-F6F9-B06FE4224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7166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4E2DF3-49C5-5361-86FB-AE7D93239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E28663-D4BA-59AC-4917-6F954D8098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9DFC93-58E0-8919-98C8-89971C82C9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47957B-C060-8733-04B4-B098BB5E9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ACD539-597B-099B-8A73-73D6108B43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89720B-822E-8D76-D9FF-13D59D53D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3181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A7C261-0B59-CAA1-3C49-69887EDFC5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66E9437-7317-4259-D8CC-554D3B72E6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F8EBF0-792C-AFF7-F119-9C076FBB52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545911-0F4C-1D21-FAE8-E3CAD0740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5AA2EE-C411-E081-13C0-8A24461BB1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38EDC1-430F-959F-F7E7-32B2E853C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6618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1C0B2D-BF57-C1AC-0BDD-79CFD019F3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5B1540-FF02-D284-DB98-2C2521D9B9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545E9D-BA32-2D21-720E-C286F2EEE8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D68262-5227-4EE0-9A77-90FAF7C09064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8C6B3D-6CE0-2D33-E613-85F9906B58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BC838-714F-9D60-29C1-1538EDAB70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5B47CDF-A4F0-49FE-B564-A49262787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930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f"/><Relationship Id="rId3" Type="http://schemas.microsoft.com/office/2007/relationships/hdphoto" Target="../media/hdphoto1.wdp"/><Relationship Id="rId7" Type="http://schemas.openxmlformats.org/officeDocument/2006/relationships/image" Target="../media/image13.tiff"/><Relationship Id="rId12" Type="http://schemas.openxmlformats.org/officeDocument/2006/relationships/image" Target="../media/image18.emf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f"/><Relationship Id="rId11" Type="http://schemas.openxmlformats.org/officeDocument/2006/relationships/image" Target="../media/image17.emf"/><Relationship Id="rId5" Type="http://schemas.microsoft.com/office/2007/relationships/hdphoto" Target="../media/hdphoto2.wdp"/><Relationship Id="rId10" Type="http://schemas.openxmlformats.org/officeDocument/2006/relationships/image" Target="../media/image16.emf"/><Relationship Id="rId4" Type="http://schemas.openxmlformats.org/officeDocument/2006/relationships/image" Target="../media/image11.png"/><Relationship Id="rId9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2B5B2BE-B23F-9DF8-9672-3A6E4FA2F92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007"/>
          <a:stretch/>
        </p:blipFill>
        <p:spPr>
          <a:xfrm>
            <a:off x="6236753" y="312419"/>
            <a:ext cx="5717122" cy="280119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BE90E7F-487A-0230-0778-109AFD2AA58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682" b="3719"/>
          <a:stretch/>
        </p:blipFill>
        <p:spPr>
          <a:xfrm>
            <a:off x="2787040" y="3355646"/>
            <a:ext cx="6899426" cy="339964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5A37493-A438-B073-C972-BFB6C2ADAA1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007"/>
          <a:stretch/>
        </p:blipFill>
        <p:spPr>
          <a:xfrm>
            <a:off x="238126" y="312419"/>
            <a:ext cx="5717122" cy="280119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29AC27E-608C-181C-A4D6-15A758A9A5EA}"/>
              </a:ext>
            </a:extLst>
          </p:cNvPr>
          <p:cNvSpPr txBox="1"/>
          <p:nvPr/>
        </p:nvSpPr>
        <p:spPr>
          <a:xfrm>
            <a:off x="161926" y="70385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90FD77D-E0B5-5E3A-5EF9-CEA1B97DDFB0}"/>
              </a:ext>
            </a:extLst>
          </p:cNvPr>
          <p:cNvSpPr txBox="1"/>
          <p:nvPr/>
        </p:nvSpPr>
        <p:spPr>
          <a:xfrm>
            <a:off x="2551382" y="324219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AFEE865-71F0-2634-FC21-C8D4CAABFF80}"/>
              </a:ext>
            </a:extLst>
          </p:cNvPr>
          <p:cNvSpPr txBox="1"/>
          <p:nvPr/>
        </p:nvSpPr>
        <p:spPr>
          <a:xfrm>
            <a:off x="161925" y="3897333"/>
            <a:ext cx="2422793" cy="24554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:Visualisation of spatial transcriptomic quality metrics. (A) Bar chart visualisation of genes and unique molecular identifiers (UMIs) per array spot of the </a:t>
            </a:r>
            <a:r>
              <a:rPr lang="en-GB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Visium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10X Genomics spatial slide (n=4 control and flow samples, matched patient tissue). (B) Correlation of normalised expression data compared with the number of detected genes from raw count data per sample (</a:t>
            </a:r>
            <a:r>
              <a:rPr lang="en-GB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_Count_Spatial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.</a:t>
            </a:r>
            <a:endParaRPr lang="en-GB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722DF2-2F53-C931-7174-5BED055042C6}"/>
              </a:ext>
            </a:extLst>
          </p:cNvPr>
          <p:cNvSpPr txBox="1"/>
          <p:nvPr/>
        </p:nvSpPr>
        <p:spPr>
          <a:xfrm rot="16200000">
            <a:off x="-203647" y="828871"/>
            <a:ext cx="684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Contr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91019EA-CF31-8336-1A51-23294AA93F97}"/>
              </a:ext>
            </a:extLst>
          </p:cNvPr>
          <p:cNvSpPr txBox="1"/>
          <p:nvPr/>
        </p:nvSpPr>
        <p:spPr>
          <a:xfrm rot="16200000">
            <a:off x="5762339" y="828871"/>
            <a:ext cx="684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Contr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380B7B8-9414-A6E3-6589-5A9B72FF9A95}"/>
              </a:ext>
            </a:extLst>
          </p:cNvPr>
          <p:cNvSpPr txBox="1"/>
          <p:nvPr/>
        </p:nvSpPr>
        <p:spPr>
          <a:xfrm rot="16200000">
            <a:off x="-87566" y="2204229"/>
            <a:ext cx="498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low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A03A430-F88D-64B9-47FA-A9625DA3EA32}"/>
              </a:ext>
            </a:extLst>
          </p:cNvPr>
          <p:cNvSpPr txBox="1"/>
          <p:nvPr/>
        </p:nvSpPr>
        <p:spPr>
          <a:xfrm rot="16200000">
            <a:off x="5854992" y="2204229"/>
            <a:ext cx="498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low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A8A1ED6-355E-9794-5E25-1C005C5F8E7E}"/>
              </a:ext>
            </a:extLst>
          </p:cNvPr>
          <p:cNvSpPr txBox="1"/>
          <p:nvPr/>
        </p:nvSpPr>
        <p:spPr>
          <a:xfrm rot="16200000">
            <a:off x="2492584" y="4004327"/>
            <a:ext cx="684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Contr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8205CA9-E07A-D8CD-7179-F2FD1197F3B2}"/>
              </a:ext>
            </a:extLst>
          </p:cNvPr>
          <p:cNvSpPr txBox="1"/>
          <p:nvPr/>
        </p:nvSpPr>
        <p:spPr>
          <a:xfrm rot="16200000">
            <a:off x="2584523" y="5895178"/>
            <a:ext cx="498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low</a:t>
            </a:r>
          </a:p>
        </p:txBody>
      </p:sp>
    </p:spTree>
    <p:extLst>
      <p:ext uri="{BB962C8B-B14F-4D97-AF65-F5344CB8AC3E}">
        <p14:creationId xmlns:p14="http://schemas.microsoft.com/office/powerpoint/2010/main" val="34729219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5CD085DB-0CB7-9E56-9C34-8BF2D76DAFC6}"/>
              </a:ext>
            </a:extLst>
          </p:cNvPr>
          <p:cNvGrpSpPr/>
          <p:nvPr/>
        </p:nvGrpSpPr>
        <p:grpSpPr>
          <a:xfrm>
            <a:off x="1495883" y="925739"/>
            <a:ext cx="5233015" cy="5337175"/>
            <a:chOff x="2323197" y="911225"/>
            <a:chExt cx="5233015" cy="533717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500EB78-3B3F-71FE-357C-19A7DFD5C846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84212" y="949325"/>
              <a:ext cx="1872000" cy="26416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ED7FC9A-376C-C747-7B74-6FD8EBB733CE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94192" y="935038"/>
              <a:ext cx="1872000" cy="26416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250A862-69AD-CF51-36C9-0554698EC82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23197" y="911225"/>
              <a:ext cx="1872000" cy="26416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EF6E3AA-0821-D1C6-AF21-87CA2C7D569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23197" y="3552825"/>
              <a:ext cx="1872000" cy="26416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DF4B2BB-BCEF-6488-21FD-E3C2A08987E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993187" y="3600450"/>
              <a:ext cx="1872000" cy="26416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27829A5-3EA7-BB18-0B78-0B923D4A298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684212" y="3606800"/>
              <a:ext cx="1872000" cy="2641600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6863C619-1BF1-0F6C-288D-672943F56D66}"/>
              </a:ext>
            </a:extLst>
          </p:cNvPr>
          <p:cNvSpPr txBox="1"/>
          <p:nvPr/>
        </p:nvSpPr>
        <p:spPr>
          <a:xfrm>
            <a:off x="7550290" y="726095"/>
            <a:ext cx="4191911" cy="20602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2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: Quantification of reverse transcriptase polymerase chain reaction (RT-PCR) fold change expression of selected markers from spatial transcriptomic data. Values from four independent experiments and mean values are shown. (TWIST2 = Twist Family BHLH Transcription Factor 2; MCP-1 = Monocyte Chemotactic Protein-1; IL-8 = Interleukin-8; BCL2 = BCL2 Apoptosis Regulator; VEGFA = Vascular Endothelial Growth Factor Alpha; THBD = Thrombomodulin; NR3C1 = Nuclear Receptor Subfamily 3 Group C Member 1). (p &lt; 0.05 = *; p &lt; 0.01 = **; p &lt; 0.001, paired t-test).</a:t>
            </a:r>
            <a:endParaRPr lang="en-GB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59139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FE57356D-FBDD-4844-B5D5-F31E10E4B1F5}"/>
              </a:ext>
            </a:extLst>
          </p:cNvPr>
          <p:cNvSpPr txBox="1"/>
          <p:nvPr/>
        </p:nvSpPr>
        <p:spPr>
          <a:xfrm>
            <a:off x="44364" y="1509901"/>
            <a:ext cx="1298729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>
              <a:defRPr/>
            </a:pPr>
            <a:r>
              <a:rPr lang="en-GB" sz="2400" b="1" dirty="0" err="1">
                <a:solidFill>
                  <a:srgbClr val="FF0000"/>
                </a:solidFill>
                <a:latin typeface="Calibri" panose="020F0502020204030204"/>
              </a:rPr>
              <a:t>pNFKB</a:t>
            </a:r>
            <a:endParaRPr lang="en-GB" sz="2400" b="1" dirty="0">
              <a:solidFill>
                <a:srgbClr val="000000"/>
              </a:solidFill>
              <a:latin typeface="Calibri" panose="020F0502020204030204"/>
              <a:cs typeface="Calibri"/>
            </a:endParaRPr>
          </a:p>
          <a:p>
            <a:pPr algn="ctr">
              <a:defRPr/>
            </a:pPr>
            <a:r>
              <a:rPr lang="en-GB" sz="2400" b="1" dirty="0">
                <a:solidFill>
                  <a:srgbClr val="00B050"/>
                </a:solidFill>
                <a:latin typeface="Calibri" panose="020F0502020204030204"/>
                <a:cs typeface="Arial"/>
              </a:rPr>
              <a:t>CD31</a:t>
            </a:r>
            <a:endParaRPr lang="en-GB" sz="2400" b="1" dirty="0">
              <a:solidFill>
                <a:srgbClr val="000000"/>
              </a:solidFill>
              <a:latin typeface="Calibri" panose="020F0502020204030204"/>
              <a:cs typeface="Arial"/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D3E307AE-D5C6-4FDF-8BCE-39889E13337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5088" y="992583"/>
            <a:ext cx="1800001" cy="180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7DC277F-6CBD-4BDC-A3ED-B894850EA92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143252" y="1003727"/>
            <a:ext cx="1799999" cy="180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ACD483C-898F-4C54-A233-99FA12C82672}"/>
              </a:ext>
            </a:extLst>
          </p:cNvPr>
          <p:cNvSpPr txBox="1"/>
          <p:nvPr/>
        </p:nvSpPr>
        <p:spPr>
          <a:xfrm>
            <a:off x="1587760" y="401190"/>
            <a:ext cx="11285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GB" sz="2400" b="1" dirty="0">
                <a:solidFill>
                  <a:prstClr val="black"/>
                </a:solidFill>
                <a:latin typeface="Calibri" panose="020F0502020204030204"/>
              </a:rPr>
              <a:t>Contro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8B4C3AA-D62E-4593-A48A-B3B33B5E64D6}"/>
              </a:ext>
            </a:extLst>
          </p:cNvPr>
          <p:cNvSpPr txBox="1"/>
          <p:nvPr/>
        </p:nvSpPr>
        <p:spPr>
          <a:xfrm>
            <a:off x="3156172" y="393723"/>
            <a:ext cx="18143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GB" sz="2400" b="1" dirty="0">
                <a:solidFill>
                  <a:prstClr val="black"/>
                </a:solidFill>
                <a:latin typeface="Calibri" panose="020F0502020204030204"/>
              </a:rPr>
              <a:t>45 mins flow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EB493E3-4890-4456-8936-4C6418BE128E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168359" y="4776385"/>
            <a:ext cx="1800000" cy="180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307BC41-11FB-4178-8777-33E1BEE16CA0}"/>
              </a:ext>
            </a:extLst>
          </p:cNvPr>
          <p:cNvSpPr txBox="1"/>
          <p:nvPr/>
        </p:nvSpPr>
        <p:spPr>
          <a:xfrm>
            <a:off x="118265" y="3508828"/>
            <a:ext cx="1298729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>
              <a:defRPr/>
            </a:pPr>
            <a:r>
              <a:rPr lang="en-GB" sz="2400" b="1" dirty="0">
                <a:solidFill>
                  <a:srgbClr val="FF0000"/>
                </a:solidFill>
                <a:latin typeface="Calibri" panose="020F0502020204030204"/>
              </a:rPr>
              <a:t>pp38</a:t>
            </a:r>
            <a:endParaRPr lang="en-GB" sz="2400" b="1" dirty="0">
              <a:solidFill>
                <a:srgbClr val="000000"/>
              </a:solidFill>
              <a:latin typeface="Calibri" panose="020F0502020204030204"/>
              <a:cs typeface="Calibri"/>
            </a:endParaRPr>
          </a:p>
          <a:p>
            <a:pPr algn="ctr">
              <a:defRPr/>
            </a:pPr>
            <a:r>
              <a:rPr lang="en-GB" sz="2400" b="1" dirty="0">
                <a:solidFill>
                  <a:srgbClr val="00B050"/>
                </a:solidFill>
                <a:latin typeface="Calibri" panose="020F0502020204030204"/>
                <a:cs typeface="Arial"/>
              </a:rPr>
              <a:t>CD31</a:t>
            </a:r>
            <a:endParaRPr lang="en-GB" sz="2400" b="1" dirty="0">
              <a:solidFill>
                <a:srgbClr val="000000"/>
              </a:solidFill>
              <a:latin typeface="Calibri" panose="020F0502020204030204"/>
              <a:cs typeface="Arial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2A62B2-AE1A-4EDF-8F43-36A00E2ECD63}"/>
              </a:ext>
            </a:extLst>
          </p:cNvPr>
          <p:cNvSpPr txBox="1"/>
          <p:nvPr/>
        </p:nvSpPr>
        <p:spPr>
          <a:xfrm>
            <a:off x="61483" y="5295963"/>
            <a:ext cx="1298729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>
              <a:defRPr/>
            </a:pPr>
            <a:r>
              <a:rPr lang="en-GB" sz="2400" b="1" dirty="0" err="1">
                <a:solidFill>
                  <a:srgbClr val="FF0000"/>
                </a:solidFill>
                <a:latin typeface="Calibri" panose="020F0502020204030204"/>
              </a:rPr>
              <a:t>psmad</a:t>
            </a:r>
            <a:endParaRPr lang="en-GB" sz="2400" b="1" dirty="0">
              <a:solidFill>
                <a:srgbClr val="000000"/>
              </a:solidFill>
              <a:latin typeface="Calibri" panose="020F0502020204030204"/>
              <a:cs typeface="Calibri"/>
            </a:endParaRPr>
          </a:p>
          <a:p>
            <a:pPr algn="ctr">
              <a:defRPr/>
            </a:pPr>
            <a:r>
              <a:rPr lang="en-GB" sz="2400" b="1" dirty="0">
                <a:solidFill>
                  <a:srgbClr val="00B050"/>
                </a:solidFill>
                <a:latin typeface="Calibri" panose="020F0502020204030204"/>
                <a:cs typeface="Arial"/>
              </a:rPr>
              <a:t>CD31</a:t>
            </a:r>
            <a:endParaRPr lang="en-GB" sz="2400" b="1" dirty="0">
              <a:solidFill>
                <a:srgbClr val="000000"/>
              </a:solidFill>
              <a:latin typeface="Calibri" panose="020F0502020204030204"/>
              <a:cs typeface="Arial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6B881CFB-4B56-4934-9479-A9E0B8076D5E}"/>
              </a:ext>
            </a:extLst>
          </p:cNvPr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285089" y="4776386"/>
            <a:ext cx="1800000" cy="18000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E51F99F0-5BE8-4C06-8A41-C26731F8A028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285089" y="2882526"/>
            <a:ext cx="1800000" cy="18000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2D0BCC2-7A62-4B4A-931D-5EE8839743EA}"/>
              </a:ext>
            </a:extLst>
          </p:cNvPr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6172" y="2890056"/>
            <a:ext cx="1800000" cy="180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E0ABE02-6170-96E3-D471-DEE0C2640CD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757290" y="855388"/>
            <a:ext cx="2015022" cy="254116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FBF2838-B6EA-CF7D-18A5-9BB721EC6FD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742268" y="855388"/>
            <a:ext cx="2015022" cy="254116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9691D14-600C-DC9F-58C7-8B26230ACFE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27246" y="855388"/>
            <a:ext cx="2015022" cy="254116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BAF24D1-2BC1-5C34-4DC8-30653011B18D}"/>
              </a:ext>
            </a:extLst>
          </p:cNvPr>
          <p:cNvSpPr txBox="1"/>
          <p:nvPr/>
        </p:nvSpPr>
        <p:spPr>
          <a:xfrm>
            <a:off x="5727246" y="3931275"/>
            <a:ext cx="6098720" cy="18626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3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: Immunofluorescence imaging of </a:t>
            </a:r>
            <a:r>
              <a:rPr lang="en-GB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NFkB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pp38 and </a:t>
            </a:r>
            <a:r>
              <a:rPr lang="en-GB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SMAD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red) expression in long saphenous vein tissue cross section, co-stained with endothelial marker CD31 (green) for determination of expression of these marker </a:t>
            </a:r>
            <a:r>
              <a:rPr lang="en-GB" sz="12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roteins 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n response to short (45 minute) exposure to acute arterial haemodynamic conditions using specific antibodies. Representative tissue </a:t>
            </a:r>
            <a:r>
              <a:rPr lang="en-GB" sz="12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s, values from 4 independent experiments, and mean values of quantified fluorescent intensity shown. Image scale 20</a:t>
            </a:r>
            <a:r>
              <a:rPr lang="en-GB" sz="12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m.</a:t>
            </a:r>
            <a:r>
              <a:rPr lang="en-GB" sz="12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NFkB = Nuclear Factor Kappa Beta; </a:t>
            </a:r>
            <a:r>
              <a:rPr lang="en-GB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NFkB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phosphorylated NFkB; pp38 = phosphorylated p38; </a:t>
            </a:r>
            <a:r>
              <a:rPr lang="en-GB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SMAD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phosphorylated SMAD; CD31 = Platelet and Endothelial Cell Adhesion Molecule 1 (PECAM1). (p &lt; 0.05 = *; p &lt; 0.01 = **; p &lt; 0.001, paired t-test).</a:t>
            </a:r>
            <a:endParaRPr lang="en-GB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BAAA09C8-C770-985F-8F25-1972D305DBC7}"/>
              </a:ext>
            </a:extLst>
          </p:cNvPr>
          <p:cNvCxnSpPr>
            <a:cxnSpLocks/>
          </p:cNvCxnSpPr>
          <p:nvPr/>
        </p:nvCxnSpPr>
        <p:spPr>
          <a:xfrm>
            <a:off x="1319722" y="1264456"/>
            <a:ext cx="886767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36B007B2-388B-9899-50DE-5E8470944186}"/>
              </a:ext>
            </a:extLst>
          </p:cNvPr>
          <p:cNvSpPr txBox="1"/>
          <p:nvPr/>
        </p:nvSpPr>
        <p:spPr>
          <a:xfrm>
            <a:off x="1285089" y="981551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</a:rPr>
              <a:t>20 </a:t>
            </a:r>
            <a:r>
              <a:rPr lang="en-GB" sz="1200" dirty="0">
                <a:solidFill>
                  <a:schemeClr val="bg1"/>
                </a:solidFill>
                <a:sym typeface="Symbol" panose="05050102010706020507" pitchFamily="18" charset="2"/>
              </a:rPr>
              <a:t>m</a:t>
            </a:r>
            <a:endParaRPr lang="en-GB" sz="1200" dirty="0">
              <a:solidFill>
                <a:schemeClr val="bg1"/>
              </a:solidFill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26A8B99-EE88-4D2D-E990-A4B5B4B41787}"/>
              </a:ext>
            </a:extLst>
          </p:cNvPr>
          <p:cNvCxnSpPr>
            <a:cxnSpLocks/>
          </p:cNvCxnSpPr>
          <p:nvPr/>
        </p:nvCxnSpPr>
        <p:spPr>
          <a:xfrm>
            <a:off x="3215928" y="1262529"/>
            <a:ext cx="886767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43BE7F93-009C-0571-4B63-FF9AC9950288}"/>
              </a:ext>
            </a:extLst>
          </p:cNvPr>
          <p:cNvSpPr txBox="1"/>
          <p:nvPr/>
        </p:nvSpPr>
        <p:spPr>
          <a:xfrm>
            <a:off x="3181295" y="979624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</a:rPr>
              <a:t>20 </a:t>
            </a:r>
            <a:r>
              <a:rPr lang="en-GB" sz="1200" dirty="0">
                <a:solidFill>
                  <a:schemeClr val="bg1"/>
                </a:solidFill>
                <a:sym typeface="Symbol" panose="05050102010706020507" pitchFamily="18" charset="2"/>
              </a:rPr>
              <a:t>m</a:t>
            </a:r>
            <a:endParaRPr lang="en-GB" sz="1200" dirty="0">
              <a:solidFill>
                <a:schemeClr val="bg1"/>
              </a:solidFill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2E5F5F02-62C0-02C3-A173-3FAFA9A56293}"/>
              </a:ext>
            </a:extLst>
          </p:cNvPr>
          <p:cNvCxnSpPr>
            <a:cxnSpLocks/>
          </p:cNvCxnSpPr>
          <p:nvPr/>
        </p:nvCxnSpPr>
        <p:spPr>
          <a:xfrm>
            <a:off x="1272583" y="3152409"/>
            <a:ext cx="886767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17A570F2-FDAB-434D-837E-70AF45DF0D8E}"/>
              </a:ext>
            </a:extLst>
          </p:cNvPr>
          <p:cNvSpPr txBox="1"/>
          <p:nvPr/>
        </p:nvSpPr>
        <p:spPr>
          <a:xfrm>
            <a:off x="1237950" y="2869504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</a:rPr>
              <a:t>20 </a:t>
            </a:r>
            <a:r>
              <a:rPr lang="en-GB" sz="1200" dirty="0">
                <a:solidFill>
                  <a:schemeClr val="bg1"/>
                </a:solidFill>
                <a:sym typeface="Symbol" panose="05050102010706020507" pitchFamily="18" charset="2"/>
              </a:rPr>
              <a:t>m</a:t>
            </a:r>
            <a:endParaRPr lang="en-GB" sz="1200" dirty="0">
              <a:solidFill>
                <a:schemeClr val="bg1"/>
              </a:solidFill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087DE11D-8EF9-7813-9D3E-2A766782A53A}"/>
              </a:ext>
            </a:extLst>
          </p:cNvPr>
          <p:cNvCxnSpPr>
            <a:cxnSpLocks/>
          </p:cNvCxnSpPr>
          <p:nvPr/>
        </p:nvCxnSpPr>
        <p:spPr>
          <a:xfrm>
            <a:off x="3217212" y="3152409"/>
            <a:ext cx="886767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5A343D44-E104-018A-81C5-EFB04BD52485}"/>
              </a:ext>
            </a:extLst>
          </p:cNvPr>
          <p:cNvSpPr txBox="1"/>
          <p:nvPr/>
        </p:nvSpPr>
        <p:spPr>
          <a:xfrm>
            <a:off x="3182579" y="2869504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</a:rPr>
              <a:t>20 </a:t>
            </a:r>
            <a:r>
              <a:rPr lang="en-GB" sz="1200" dirty="0">
                <a:solidFill>
                  <a:schemeClr val="bg1"/>
                </a:solidFill>
                <a:sym typeface="Symbol" panose="05050102010706020507" pitchFamily="18" charset="2"/>
              </a:rPr>
              <a:t>m</a:t>
            </a:r>
            <a:endParaRPr lang="en-GB" sz="1200" dirty="0">
              <a:solidFill>
                <a:schemeClr val="bg1"/>
              </a:solidFill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A0252D6-66BC-CF57-EDE6-C9F236E29118}"/>
              </a:ext>
            </a:extLst>
          </p:cNvPr>
          <p:cNvCxnSpPr>
            <a:cxnSpLocks/>
          </p:cNvCxnSpPr>
          <p:nvPr/>
        </p:nvCxnSpPr>
        <p:spPr>
          <a:xfrm>
            <a:off x="1306932" y="5100851"/>
            <a:ext cx="886767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46FD1AEC-C25D-ABC5-E6D8-AF8E9BC8B906}"/>
              </a:ext>
            </a:extLst>
          </p:cNvPr>
          <p:cNvSpPr txBox="1"/>
          <p:nvPr/>
        </p:nvSpPr>
        <p:spPr>
          <a:xfrm>
            <a:off x="1272299" y="4817946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</a:rPr>
              <a:t>20 </a:t>
            </a:r>
            <a:r>
              <a:rPr lang="en-GB" sz="1200" dirty="0">
                <a:solidFill>
                  <a:schemeClr val="bg1"/>
                </a:solidFill>
                <a:sym typeface="Symbol" panose="05050102010706020507" pitchFamily="18" charset="2"/>
              </a:rPr>
              <a:t>m</a:t>
            </a:r>
            <a:endParaRPr lang="en-GB" sz="1200" dirty="0">
              <a:solidFill>
                <a:schemeClr val="bg1"/>
              </a:solidFill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AC2764E4-5104-3236-2BFA-FCD5FA666C13}"/>
              </a:ext>
            </a:extLst>
          </p:cNvPr>
          <p:cNvCxnSpPr>
            <a:cxnSpLocks/>
          </p:cNvCxnSpPr>
          <p:nvPr/>
        </p:nvCxnSpPr>
        <p:spPr>
          <a:xfrm>
            <a:off x="3215928" y="5096829"/>
            <a:ext cx="886767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85DC10E5-F5C0-EF32-6775-9E4B28D3DF40}"/>
              </a:ext>
            </a:extLst>
          </p:cNvPr>
          <p:cNvSpPr txBox="1"/>
          <p:nvPr/>
        </p:nvSpPr>
        <p:spPr>
          <a:xfrm>
            <a:off x="3181295" y="4813924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</a:rPr>
              <a:t>20 </a:t>
            </a:r>
            <a:r>
              <a:rPr lang="en-GB" sz="1200" dirty="0">
                <a:solidFill>
                  <a:schemeClr val="bg1"/>
                </a:solidFill>
                <a:sym typeface="Symbol" panose="05050102010706020507" pitchFamily="18" charset="2"/>
              </a:rPr>
              <a:t>m</a:t>
            </a:r>
            <a:endParaRPr lang="en-GB" sz="1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24179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3</TotalTime>
  <Words>349</Words>
  <Application>Microsoft Office PowerPoint</Application>
  <PresentationFormat>Widescreen</PresentationFormat>
  <Paragraphs>2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am McQueen</dc:creator>
  <cp:lastModifiedBy>McQueen, Liam W.</cp:lastModifiedBy>
  <cp:revision>2</cp:revision>
  <dcterms:created xsi:type="dcterms:W3CDTF">2024-07-02T12:16:38Z</dcterms:created>
  <dcterms:modified xsi:type="dcterms:W3CDTF">2024-08-02T20:30:04Z</dcterms:modified>
</cp:coreProperties>
</file>